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65" r:id="rId3"/>
    <p:sldId id="266" r:id="rId4"/>
    <p:sldId id="267" r:id="rId5"/>
    <p:sldId id="268" r:id="rId6"/>
    <p:sldId id="270" r:id="rId7"/>
    <p:sldId id="269" r:id="rId8"/>
    <p:sldId id="27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42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 showGuides="1">
      <p:cViewPr>
        <p:scale>
          <a:sx n="58" d="100"/>
          <a:sy n="58" d="100"/>
        </p:scale>
        <p:origin x="21" y="447"/>
      </p:cViewPr>
      <p:guideLst>
        <p:guide orient="horz" pos="4042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6E73A2-F434-442E-B35C-9019D7F646D1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84372D-A767-42E0-8FD6-3E50E4CF52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6511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22B003-EDA2-4CA2-92DF-DE7DD81AC75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2304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3029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3423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375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5286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175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945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948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1437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366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829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9748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B2D99-32CD-45A6-810D-DA982E4A0C35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2462B-095B-47EF-9E89-FE5F033CE0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29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/>
          <a:srcRect t="32167"/>
          <a:stretch/>
        </p:blipFill>
        <p:spPr>
          <a:xfrm>
            <a:off x="1771650" y="501650"/>
            <a:ext cx="8401016" cy="16666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651250" y="2098400"/>
            <a:ext cx="73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835900" y="2100754"/>
            <a:ext cx="1352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593850" y="311150"/>
            <a:ext cx="4254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A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593850" y="2597150"/>
            <a:ext cx="4254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B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673850" y="2603500"/>
            <a:ext cx="4254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4"/>
          <a:srcRect l="3735" t="6578" r="8222" b="4573"/>
          <a:stretch/>
        </p:blipFill>
        <p:spPr>
          <a:xfrm>
            <a:off x="6684279" y="2934731"/>
            <a:ext cx="3913871" cy="3168118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5"/>
          <a:srcRect r="19989" b="5973"/>
          <a:stretch/>
        </p:blipFill>
        <p:spPr>
          <a:xfrm>
            <a:off x="1854201" y="2934733"/>
            <a:ext cx="4785629" cy="302156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317751" y="6476094"/>
            <a:ext cx="531286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ure S1. The conditions for screening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dauer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related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kinases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0667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565505" y="23537"/>
            <a:ext cx="47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963729" y="-72744"/>
            <a:ext cx="47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713528" y="18371"/>
            <a:ext cx="47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65071" y="3212102"/>
            <a:ext cx="47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971320" y="3074287"/>
            <a:ext cx="47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778857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uer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lated genes modulate the expression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rofile of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genes in </a:t>
            </a:r>
            <a:r>
              <a:rPr lang="en-US" altLang="zh-CN" i="1" dirty="0" err="1" smtClean="0">
                <a:latin typeface="Times New Roman" pitchFamily="18" charset="0"/>
                <a:cs typeface="Times New Roman" pitchFamily="18" charset="0"/>
              </a:rPr>
              <a:t>C.elegans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505628" y="2949088"/>
            <a:ext cx="3133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-2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glp-1(-) </a:t>
            </a:r>
            <a:endParaRPr lang="en-US" altLang="zh-CN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156863" y="2954231"/>
            <a:ext cx="324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cy-21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glp-1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8" name="组合 97"/>
          <p:cNvGrpSpPr/>
          <p:nvPr/>
        </p:nvGrpSpPr>
        <p:grpSpPr>
          <a:xfrm>
            <a:off x="659658" y="273228"/>
            <a:ext cx="4362661" cy="2772895"/>
            <a:chOff x="-32921" y="273062"/>
            <a:chExt cx="4362661" cy="2772895"/>
          </a:xfrm>
        </p:grpSpPr>
        <p:pic>
          <p:nvPicPr>
            <p:cNvPr id="4" name="图片 3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2" t="5438" r="24576" b="5295"/>
            <a:stretch/>
          </p:blipFill>
          <p:spPr>
            <a:xfrm>
              <a:off x="331694" y="292579"/>
              <a:ext cx="2649304" cy="2378903"/>
            </a:xfrm>
            <a:prstGeom prst="rect">
              <a:avLst/>
            </a:prstGeom>
          </p:spPr>
        </p:pic>
        <p:grpSp>
          <p:nvGrpSpPr>
            <p:cNvPr id="40" name="组合 39"/>
            <p:cNvGrpSpPr/>
            <p:nvPr/>
          </p:nvGrpSpPr>
          <p:grpSpPr>
            <a:xfrm>
              <a:off x="2487808" y="352465"/>
              <a:ext cx="1841932" cy="1107996"/>
              <a:chOff x="8001979" y="2780084"/>
              <a:chExt cx="2112866" cy="1107996"/>
            </a:xfrm>
          </p:grpSpPr>
          <p:sp>
            <p:nvSpPr>
              <p:cNvPr id="41" name="文本框 40"/>
              <p:cNvSpPr txBox="1"/>
              <p:nvPr/>
            </p:nvSpPr>
            <p:spPr>
              <a:xfrm>
                <a:off x="8001979" y="2780084"/>
                <a:ext cx="211286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alue</a:t>
                </a:r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2FoldChange|&gt;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UP 285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DOWN 2514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NO 14657</a:t>
                </a:r>
              </a:p>
              <a:p>
                <a:endPara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2" name="图片 4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23172" y="3166180"/>
                <a:ext cx="169001" cy="468842"/>
              </a:xfrm>
              <a:prstGeom prst="rect">
                <a:avLst/>
              </a:prstGeom>
            </p:spPr>
          </p:pic>
        </p:grpSp>
        <p:sp>
          <p:nvSpPr>
            <p:cNvPr id="43" name="文本框 42"/>
            <p:cNvSpPr txBox="1"/>
            <p:nvPr/>
          </p:nvSpPr>
          <p:spPr>
            <a:xfrm rot="16200000">
              <a:off x="-704539" y="1023385"/>
              <a:ext cx="16202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g10(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ue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037442" y="2768958"/>
              <a:ext cx="1576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FoldChang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01789" y="1678870"/>
              <a:ext cx="465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05080" y="968061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06677" y="273062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378813" y="2644763"/>
              <a:ext cx="43250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9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920436" y="2647470"/>
              <a:ext cx="432746" cy="2537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398965" y="2649846"/>
              <a:ext cx="2276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519325" y="2649710"/>
              <a:ext cx="2242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2173046" y="2642885"/>
              <a:ext cx="3145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2691564" y="2647267"/>
              <a:ext cx="4694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8" name="组合 107"/>
          <p:cNvGrpSpPr/>
          <p:nvPr/>
        </p:nvGrpSpPr>
        <p:grpSpPr>
          <a:xfrm>
            <a:off x="731842" y="3383969"/>
            <a:ext cx="4292473" cy="2826449"/>
            <a:chOff x="42558" y="3383969"/>
            <a:chExt cx="4292473" cy="2826449"/>
          </a:xfrm>
        </p:grpSpPr>
        <p:pic>
          <p:nvPicPr>
            <p:cNvPr id="7" name="图片 6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3" t="4156" r="24633" b="5616"/>
            <a:stretch/>
          </p:blipFill>
          <p:spPr>
            <a:xfrm>
              <a:off x="337457" y="3509575"/>
              <a:ext cx="2639156" cy="2372339"/>
            </a:xfrm>
            <a:prstGeom prst="rect">
              <a:avLst/>
            </a:prstGeom>
          </p:spPr>
        </p:pic>
        <p:grpSp>
          <p:nvGrpSpPr>
            <p:cNvPr id="37" name="组合 36"/>
            <p:cNvGrpSpPr/>
            <p:nvPr/>
          </p:nvGrpSpPr>
          <p:grpSpPr>
            <a:xfrm>
              <a:off x="2493099" y="3383969"/>
              <a:ext cx="1841932" cy="1107996"/>
              <a:chOff x="8001979" y="2780084"/>
              <a:chExt cx="2112866" cy="1107996"/>
            </a:xfrm>
          </p:grpSpPr>
          <p:sp>
            <p:nvSpPr>
              <p:cNvPr id="38" name="文本框 37"/>
              <p:cNvSpPr txBox="1"/>
              <p:nvPr/>
            </p:nvSpPr>
            <p:spPr>
              <a:xfrm>
                <a:off x="8001979" y="2780084"/>
                <a:ext cx="211286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alue</a:t>
                </a:r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2FoldChange|&gt;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UP 102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DOWN 102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NO 18622</a:t>
                </a:r>
              </a:p>
              <a:p>
                <a:endPara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9" name="图片 3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23172" y="3166180"/>
                <a:ext cx="169001" cy="468842"/>
              </a:xfrm>
              <a:prstGeom prst="rect">
                <a:avLst/>
              </a:prstGeom>
            </p:spPr>
          </p:pic>
        </p:grpSp>
        <p:sp>
          <p:nvSpPr>
            <p:cNvPr id="76" name="文本框 75"/>
            <p:cNvSpPr txBox="1"/>
            <p:nvPr/>
          </p:nvSpPr>
          <p:spPr>
            <a:xfrm rot="16200000">
              <a:off x="-629060" y="4169278"/>
              <a:ext cx="16202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g10(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ue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1037442" y="5933419"/>
              <a:ext cx="1576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FoldChang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96647" y="4575435"/>
              <a:ext cx="465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125674" y="3533885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360667" y="5812863"/>
              <a:ext cx="39712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927693" y="5815570"/>
              <a:ext cx="38794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1384449" y="5817946"/>
              <a:ext cx="2276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1530212" y="5817810"/>
              <a:ext cx="2242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2104103" y="5810985"/>
              <a:ext cx="3145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2677048" y="5815367"/>
              <a:ext cx="4694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0" name="组合 109"/>
          <p:cNvGrpSpPr/>
          <p:nvPr/>
        </p:nvGrpSpPr>
        <p:grpSpPr>
          <a:xfrm>
            <a:off x="4306303" y="3507480"/>
            <a:ext cx="4185042" cy="2673647"/>
            <a:chOff x="3790973" y="3275837"/>
            <a:chExt cx="4185042" cy="2673647"/>
          </a:xfrm>
        </p:grpSpPr>
        <p:pic>
          <p:nvPicPr>
            <p:cNvPr id="8" name="图片 7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73" t="3205" r="24979" b="6146"/>
            <a:stretch/>
          </p:blipFill>
          <p:spPr>
            <a:xfrm>
              <a:off x="4118096" y="3275837"/>
              <a:ext cx="2673757" cy="2359998"/>
            </a:xfrm>
            <a:prstGeom prst="rect">
              <a:avLst/>
            </a:prstGeom>
          </p:spPr>
        </p:pic>
        <p:grpSp>
          <p:nvGrpSpPr>
            <p:cNvPr id="34" name="组合 33"/>
            <p:cNvGrpSpPr/>
            <p:nvPr/>
          </p:nvGrpSpPr>
          <p:grpSpPr>
            <a:xfrm>
              <a:off x="6134083" y="3390842"/>
              <a:ext cx="1841932" cy="1107996"/>
              <a:chOff x="8001979" y="2780084"/>
              <a:chExt cx="2112866" cy="1107996"/>
            </a:xfrm>
          </p:grpSpPr>
          <p:sp>
            <p:nvSpPr>
              <p:cNvPr id="35" name="文本框 34"/>
              <p:cNvSpPr txBox="1"/>
              <p:nvPr/>
            </p:nvSpPr>
            <p:spPr>
              <a:xfrm>
                <a:off x="8001979" y="2780084"/>
                <a:ext cx="211286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alue</a:t>
                </a:r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2FoldChange|&gt;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UP 84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DOWN 38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NO 18826</a:t>
                </a:r>
              </a:p>
              <a:p>
                <a:endPara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6" name="图片 3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23172" y="3166180"/>
                <a:ext cx="169001" cy="468842"/>
              </a:xfrm>
              <a:prstGeom prst="rect">
                <a:avLst/>
              </a:prstGeom>
            </p:spPr>
          </p:pic>
        </p:grpSp>
        <p:sp>
          <p:nvSpPr>
            <p:cNvPr id="87" name="文本框 86"/>
            <p:cNvSpPr txBox="1"/>
            <p:nvPr/>
          </p:nvSpPr>
          <p:spPr>
            <a:xfrm rot="16200000">
              <a:off x="3119355" y="3987225"/>
              <a:ext cx="16202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g10(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ue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4843015" y="5672485"/>
              <a:ext cx="1576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FoldChang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3959281" y="4530756"/>
              <a:ext cx="465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3945330" y="3684939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4106730" y="5568092"/>
              <a:ext cx="51201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4743258" y="5568093"/>
              <a:ext cx="51770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5242616" y="5565765"/>
              <a:ext cx="2276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5407212" y="5568093"/>
              <a:ext cx="2242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5868866" y="5567608"/>
              <a:ext cx="3145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6505699" y="5564185"/>
              <a:ext cx="4694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1" name="组合 100"/>
          <p:cNvGrpSpPr/>
          <p:nvPr/>
        </p:nvGrpSpPr>
        <p:grpSpPr>
          <a:xfrm>
            <a:off x="4287275" y="194161"/>
            <a:ext cx="4252308" cy="2788919"/>
            <a:chOff x="3573846" y="161997"/>
            <a:chExt cx="4252308" cy="2788919"/>
          </a:xfrm>
        </p:grpSpPr>
        <p:pic>
          <p:nvPicPr>
            <p:cNvPr id="5" name="图片 4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11" t="3629" r="24623" b="5812"/>
            <a:stretch/>
          </p:blipFill>
          <p:spPr>
            <a:xfrm>
              <a:off x="3925111" y="268164"/>
              <a:ext cx="2635042" cy="2368032"/>
            </a:xfrm>
            <a:prstGeom prst="rect">
              <a:avLst/>
            </a:prstGeom>
          </p:spPr>
        </p:pic>
        <p:grpSp>
          <p:nvGrpSpPr>
            <p:cNvPr id="31" name="组合 30"/>
            <p:cNvGrpSpPr/>
            <p:nvPr/>
          </p:nvGrpSpPr>
          <p:grpSpPr>
            <a:xfrm>
              <a:off x="5984222" y="161997"/>
              <a:ext cx="1841932" cy="1107996"/>
              <a:chOff x="8001979" y="2780084"/>
              <a:chExt cx="2112866" cy="1107996"/>
            </a:xfrm>
          </p:grpSpPr>
          <p:sp>
            <p:nvSpPr>
              <p:cNvPr id="32" name="文本框 31"/>
              <p:cNvSpPr txBox="1"/>
              <p:nvPr/>
            </p:nvSpPr>
            <p:spPr>
              <a:xfrm>
                <a:off x="8001979" y="2780084"/>
                <a:ext cx="211286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alue</a:t>
                </a:r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2FoldChange|&gt;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UP 1022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DOWN 86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NO 18258</a:t>
                </a:r>
              </a:p>
              <a:p>
                <a:endPara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3" name="图片 3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23172" y="3166180"/>
                <a:ext cx="169001" cy="468842"/>
              </a:xfrm>
              <a:prstGeom prst="rect">
                <a:avLst/>
              </a:prstGeom>
            </p:spPr>
          </p:pic>
        </p:grpSp>
        <p:sp>
          <p:nvSpPr>
            <p:cNvPr id="54" name="文本框 53"/>
            <p:cNvSpPr txBox="1"/>
            <p:nvPr/>
          </p:nvSpPr>
          <p:spPr>
            <a:xfrm rot="16200000">
              <a:off x="2902228" y="1012443"/>
              <a:ext cx="16202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g10(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ue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4556547" y="2673917"/>
              <a:ext cx="1576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FoldChang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3776652" y="1828440"/>
              <a:ext cx="465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3706983" y="1287858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3708580" y="738774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3922351" y="2601473"/>
              <a:ext cx="45416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4478566" y="2558704"/>
              <a:ext cx="44234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4923047" y="2561080"/>
              <a:ext cx="2276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5062863" y="2560944"/>
              <a:ext cx="2242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5755496" y="2554119"/>
              <a:ext cx="3145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6264286" y="2558501"/>
              <a:ext cx="4694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/>
            <p:cNvSpPr txBox="1"/>
            <p:nvPr/>
          </p:nvSpPr>
          <p:spPr>
            <a:xfrm>
              <a:off x="3707978" y="180930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7" name="组合 106"/>
          <p:cNvGrpSpPr/>
          <p:nvPr/>
        </p:nvGrpSpPr>
        <p:grpSpPr>
          <a:xfrm>
            <a:off x="7957504" y="259853"/>
            <a:ext cx="4498593" cy="2738860"/>
            <a:chOff x="7426716" y="247661"/>
            <a:chExt cx="4498593" cy="2738860"/>
          </a:xfrm>
        </p:grpSpPr>
        <p:pic>
          <p:nvPicPr>
            <p:cNvPr id="25" name="图片 24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20" t="3802" r="23846" b="5694"/>
            <a:stretch/>
          </p:blipFill>
          <p:spPr>
            <a:xfrm>
              <a:off x="7795260" y="285484"/>
              <a:ext cx="2640994" cy="2370848"/>
            </a:xfrm>
            <a:prstGeom prst="rect">
              <a:avLst/>
            </a:prstGeom>
          </p:spPr>
        </p:pic>
        <p:grpSp>
          <p:nvGrpSpPr>
            <p:cNvPr id="28" name="组合 27"/>
            <p:cNvGrpSpPr/>
            <p:nvPr/>
          </p:nvGrpSpPr>
          <p:grpSpPr>
            <a:xfrm>
              <a:off x="10083377" y="337588"/>
              <a:ext cx="1841932" cy="1107996"/>
              <a:chOff x="8001979" y="2780084"/>
              <a:chExt cx="2112866" cy="1107996"/>
            </a:xfrm>
          </p:grpSpPr>
          <p:sp>
            <p:nvSpPr>
              <p:cNvPr id="29" name="文本框 28"/>
              <p:cNvSpPr txBox="1"/>
              <p:nvPr/>
            </p:nvSpPr>
            <p:spPr>
              <a:xfrm>
                <a:off x="8001979" y="2780084"/>
                <a:ext cx="211286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alue</a:t>
                </a:r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2FoldChange|&gt;0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UP 36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DOWN 32</a:t>
                </a:r>
              </a:p>
              <a:p>
                <a:r>
                  <a:rPr lang="en-US" altLang="zh-CN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NO 18616</a:t>
                </a:r>
              </a:p>
              <a:p>
                <a:endPara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23172" y="3166180"/>
                <a:ext cx="169001" cy="468842"/>
              </a:xfrm>
              <a:prstGeom prst="rect">
                <a:avLst/>
              </a:prstGeom>
            </p:spPr>
          </p:pic>
        </p:grpSp>
        <p:sp>
          <p:nvSpPr>
            <p:cNvPr id="65" name="文本框 64"/>
            <p:cNvSpPr txBox="1"/>
            <p:nvPr/>
          </p:nvSpPr>
          <p:spPr>
            <a:xfrm rot="16200000">
              <a:off x="6755098" y="1023385"/>
              <a:ext cx="16202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g10(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lue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8437643" y="2709522"/>
              <a:ext cx="1576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2FoldChang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7577832" y="247661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7769870" y="2585327"/>
              <a:ext cx="4941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8444081" y="2588034"/>
              <a:ext cx="42024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8982046" y="2590410"/>
              <a:ext cx="2276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9646399" y="2583449"/>
              <a:ext cx="3145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10155773" y="2587831"/>
              <a:ext cx="46947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文本框 102"/>
            <p:cNvSpPr txBox="1"/>
            <p:nvPr/>
          </p:nvSpPr>
          <p:spPr>
            <a:xfrm>
              <a:off x="7647961" y="1855699"/>
              <a:ext cx="4659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7578292" y="1319689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7589033" y="788893"/>
              <a:ext cx="7046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1" name="文本框 110"/>
          <p:cNvSpPr txBox="1"/>
          <p:nvPr/>
        </p:nvSpPr>
        <p:spPr>
          <a:xfrm>
            <a:off x="982748" y="2955443"/>
            <a:ext cx="3255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+) </a:t>
            </a:r>
          </a:p>
        </p:txBody>
      </p:sp>
      <p:sp>
        <p:nvSpPr>
          <p:cNvPr id="112" name="文本框 111"/>
          <p:cNvSpPr txBox="1"/>
          <p:nvPr/>
        </p:nvSpPr>
        <p:spPr>
          <a:xfrm>
            <a:off x="868535" y="6182928"/>
            <a:ext cx="3437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47D12.9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glp-1(-) </a:t>
            </a:r>
            <a:endParaRPr lang="en-US" altLang="zh-CN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4485532" y="6182928"/>
            <a:ext cx="3471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02B12.12(</a:t>
            </a:r>
            <a:r>
              <a:rPr lang="en-US" altLang="zh-CN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-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4440(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glp-1(-) </a:t>
            </a:r>
            <a:endParaRPr lang="en-US" altLang="zh-CN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5646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638829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(-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 increase the biological progres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2340429" y="-82097"/>
            <a:ext cx="6858000" cy="6559027"/>
            <a:chOff x="2340429" y="-82097"/>
            <a:chExt cx="6858000" cy="6559027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54"/>
            <a:stretch/>
          </p:blipFill>
          <p:spPr>
            <a:xfrm>
              <a:off x="2340429" y="-82097"/>
              <a:ext cx="6858000" cy="6291943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4011088" y="6169153"/>
              <a:ext cx="39070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s.</a:t>
              </a:r>
              <a:r>
                <a:rPr lang="zh-CN" alt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88060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2667000" y="0"/>
            <a:ext cx="6858000" cy="6488668"/>
            <a:chOff x="2667000" y="0"/>
            <a:chExt cx="6858000" cy="648866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13"/>
            <a:stretch/>
          </p:blipFill>
          <p:spPr>
            <a:xfrm>
              <a:off x="2667000" y="0"/>
              <a:ext cx="6858000" cy="6281057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4378432" y="6180891"/>
              <a:ext cx="42531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f-2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s.</a:t>
              </a:r>
              <a:r>
                <a: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glp-1(-) </a:t>
              </a:r>
              <a:endPara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矩形 5"/>
          <p:cNvSpPr/>
          <p:nvPr/>
        </p:nvSpPr>
        <p:spPr>
          <a:xfrm>
            <a:off x="1638829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f-2(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ress the biological progres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(-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1506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2667000" y="0"/>
            <a:ext cx="6858000" cy="6494397"/>
            <a:chOff x="2667000" y="0"/>
            <a:chExt cx="6858000" cy="6494397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839"/>
            <a:stretch/>
          </p:blipFill>
          <p:spPr>
            <a:xfrm>
              <a:off x="2667000" y="0"/>
              <a:ext cx="6858000" cy="6320413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4328440" y="6186620"/>
              <a:ext cx="38408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cy-21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glp-1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s.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r>
                <a:rPr lang="zh-CN" alt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矩形 5"/>
          <p:cNvSpPr/>
          <p:nvPr/>
        </p:nvSpPr>
        <p:spPr>
          <a:xfrm>
            <a:off x="1638829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cy-21(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ress the biological progres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(-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1067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2667000" y="0"/>
            <a:ext cx="6858000" cy="6570563"/>
            <a:chOff x="2667000" y="0"/>
            <a:chExt cx="6858000" cy="6570563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25"/>
            <a:stretch/>
          </p:blipFill>
          <p:spPr>
            <a:xfrm>
              <a:off x="2667000" y="0"/>
              <a:ext cx="6858000" cy="6280220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4204588" y="6262786"/>
              <a:ext cx="40049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47D12.9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s.</a:t>
              </a:r>
              <a:r>
                <a: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glp-1(-) </a:t>
              </a:r>
              <a:endPara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矩形 3"/>
          <p:cNvSpPr/>
          <p:nvPr/>
        </p:nvSpPr>
        <p:spPr>
          <a:xfrm>
            <a:off x="2271875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47D12.9(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ress the biological progres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(-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4066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2667000" y="0"/>
            <a:ext cx="6858000" cy="6500227"/>
            <a:chOff x="2667000" y="0"/>
            <a:chExt cx="6858000" cy="6500227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279"/>
            <a:stretch/>
          </p:blipFill>
          <p:spPr>
            <a:xfrm>
              <a:off x="2667000" y="0"/>
              <a:ext cx="6858000" cy="6290268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4204177" y="6192450"/>
              <a:ext cx="40153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02B12.12(</a:t>
              </a:r>
              <a:r>
                <a:rPr lang="en-US" altLang="zh-CN" sz="14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p-1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s.</a:t>
              </a:r>
              <a:r>
                <a: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4440(</a:t>
              </a:r>
              <a:r>
                <a:rPr lang="en-US" altLang="zh-CN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NAi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;glp-1(-) </a:t>
              </a:r>
              <a:endParaRPr lang="en-US" altLang="zh-CN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矩形 3"/>
          <p:cNvSpPr/>
          <p:nvPr/>
        </p:nvSpPr>
        <p:spPr>
          <a:xfrm>
            <a:off x="2271875" y="6488668"/>
            <a:ext cx="88484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02B12.12(</a:t>
            </a:r>
            <a:r>
              <a:rPr lang="en-US" altLang="zh-CN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ress the biological progres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p-1(-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3898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739" y="980367"/>
            <a:ext cx="4797552" cy="3874008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198260" y="6317657"/>
            <a:ext cx="102317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–Mei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curve of DCAF4L2 in patients with classical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ioma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661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5</TotalTime>
  <Words>362</Words>
  <Application>Microsoft Office PowerPoint</Application>
  <PresentationFormat>宽屏</PresentationFormat>
  <Paragraphs>108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o yuqin</dc:creator>
  <cp:lastModifiedBy>mao yuqin</cp:lastModifiedBy>
  <cp:revision>36</cp:revision>
  <dcterms:created xsi:type="dcterms:W3CDTF">2019-07-08T16:53:40Z</dcterms:created>
  <dcterms:modified xsi:type="dcterms:W3CDTF">2020-04-04T22:35:41Z</dcterms:modified>
</cp:coreProperties>
</file>